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2" r:id="rId6"/>
    <p:sldId id="263" r:id="rId7"/>
    <p:sldId id="261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C0CE30F-2463-478D-8CD7-F76E383C0411}" v="19" dt="2025-12-03T14:34:10.6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58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ian Robinson" userId="0641c4c5-2f89-46b7-a1c0-255ee54644ae" providerId="ADAL" clId="{ED66AB01-BF40-454D-9816-B00C85E3E4E3}"/>
    <pc:docChg chg="undo custSel modSld">
      <pc:chgData name="Brian Robinson" userId="0641c4c5-2f89-46b7-a1c0-255ee54644ae" providerId="ADAL" clId="{ED66AB01-BF40-454D-9816-B00C85E3E4E3}" dt="2025-12-03T15:26:03.122" v="220" actId="1036"/>
      <pc:docMkLst>
        <pc:docMk/>
      </pc:docMkLst>
      <pc:sldChg chg="modSp mod">
        <pc:chgData name="Brian Robinson" userId="0641c4c5-2f89-46b7-a1c0-255ee54644ae" providerId="ADAL" clId="{ED66AB01-BF40-454D-9816-B00C85E3E4E3}" dt="2025-12-03T14:22:24.470" v="95" actId="403"/>
        <pc:sldMkLst>
          <pc:docMk/>
          <pc:sldMk cId="349248455" sldId="257"/>
        </pc:sldMkLst>
        <pc:spChg chg="mod">
          <ac:chgData name="Brian Robinson" userId="0641c4c5-2f89-46b7-a1c0-255ee54644ae" providerId="ADAL" clId="{ED66AB01-BF40-454D-9816-B00C85E3E4E3}" dt="2025-12-03T14:12:41.665" v="31" actId="27636"/>
          <ac:spMkLst>
            <pc:docMk/>
            <pc:sldMk cId="349248455" sldId="257"/>
            <ac:spMk id="2" creationId="{4458A319-0C10-171B-BB90-693E0C455786}"/>
          </ac:spMkLst>
        </pc:spChg>
        <pc:spChg chg="mod">
          <ac:chgData name="Brian Robinson" userId="0641c4c5-2f89-46b7-a1c0-255ee54644ae" providerId="ADAL" clId="{ED66AB01-BF40-454D-9816-B00C85E3E4E3}" dt="2025-12-03T14:12:53.906" v="32" actId="14100"/>
          <ac:spMkLst>
            <pc:docMk/>
            <pc:sldMk cId="349248455" sldId="257"/>
            <ac:spMk id="3" creationId="{141E4767-9584-5800-2001-4B5E799DCE20}"/>
          </ac:spMkLst>
        </pc:spChg>
        <pc:spChg chg="mod">
          <ac:chgData name="Brian Robinson" userId="0641c4c5-2f89-46b7-a1c0-255ee54644ae" providerId="ADAL" clId="{ED66AB01-BF40-454D-9816-B00C85E3E4E3}" dt="2025-12-03T14:22:24.470" v="95" actId="403"/>
          <ac:spMkLst>
            <pc:docMk/>
            <pc:sldMk cId="349248455" sldId="257"/>
            <ac:spMk id="5" creationId="{DFFB3F8F-A8BF-C626-C958-83749942F071}"/>
          </ac:spMkLst>
        </pc:spChg>
      </pc:sldChg>
      <pc:sldChg chg="modSp mod">
        <pc:chgData name="Brian Robinson" userId="0641c4c5-2f89-46b7-a1c0-255ee54644ae" providerId="ADAL" clId="{ED66AB01-BF40-454D-9816-B00C85E3E4E3}" dt="2025-12-03T14:28:23.027" v="119" actId="1036"/>
        <pc:sldMkLst>
          <pc:docMk/>
          <pc:sldMk cId="2916643703" sldId="258"/>
        </pc:sldMkLst>
        <pc:spChg chg="mod">
          <ac:chgData name="Brian Robinson" userId="0641c4c5-2f89-46b7-a1c0-255ee54644ae" providerId="ADAL" clId="{ED66AB01-BF40-454D-9816-B00C85E3E4E3}" dt="2025-12-03T14:16:20.356" v="39" actId="20577"/>
          <ac:spMkLst>
            <pc:docMk/>
            <pc:sldMk cId="2916643703" sldId="258"/>
            <ac:spMk id="3" creationId="{5188CA69-584E-36DF-2777-F5810BAB2813}"/>
          </ac:spMkLst>
        </pc:spChg>
        <pc:spChg chg="mod">
          <ac:chgData name="Brian Robinson" userId="0641c4c5-2f89-46b7-a1c0-255ee54644ae" providerId="ADAL" clId="{ED66AB01-BF40-454D-9816-B00C85E3E4E3}" dt="2025-12-03T14:28:23.027" v="119" actId="1036"/>
          <ac:spMkLst>
            <pc:docMk/>
            <pc:sldMk cId="2916643703" sldId="258"/>
            <ac:spMk id="4" creationId="{F3B15881-F131-FDEF-D1CC-4E88BB65AA5D}"/>
          </ac:spMkLst>
        </pc:spChg>
      </pc:sldChg>
      <pc:sldChg chg="addSp delSp modSp mod">
        <pc:chgData name="Brian Robinson" userId="0641c4c5-2f89-46b7-a1c0-255ee54644ae" providerId="ADAL" clId="{ED66AB01-BF40-454D-9816-B00C85E3E4E3}" dt="2025-12-03T14:28:14.577" v="115" actId="1036"/>
        <pc:sldMkLst>
          <pc:docMk/>
          <pc:sldMk cId="846788600" sldId="259"/>
        </pc:sldMkLst>
        <pc:spChg chg="mod">
          <ac:chgData name="Brian Robinson" userId="0641c4c5-2f89-46b7-a1c0-255ee54644ae" providerId="ADAL" clId="{ED66AB01-BF40-454D-9816-B00C85E3E4E3}" dt="2025-12-03T14:19:32.395" v="54" actId="20577"/>
          <ac:spMkLst>
            <pc:docMk/>
            <pc:sldMk cId="846788600" sldId="259"/>
            <ac:spMk id="3" creationId="{49966EE5-E4C1-854A-7562-C7CFB9E302CF}"/>
          </ac:spMkLst>
        </pc:spChg>
        <pc:spChg chg="del">
          <ac:chgData name="Brian Robinson" userId="0641c4c5-2f89-46b7-a1c0-255ee54644ae" providerId="ADAL" clId="{ED66AB01-BF40-454D-9816-B00C85E3E4E3}" dt="2025-12-03T14:21:16.080" v="80" actId="478"/>
          <ac:spMkLst>
            <pc:docMk/>
            <pc:sldMk cId="846788600" sldId="259"/>
            <ac:spMk id="4" creationId="{DD252B29-31BD-1BD9-F5E8-1CBAD4CD965E}"/>
          </ac:spMkLst>
        </pc:spChg>
        <pc:spChg chg="add mod">
          <ac:chgData name="Brian Robinson" userId="0641c4c5-2f89-46b7-a1c0-255ee54644ae" providerId="ADAL" clId="{ED66AB01-BF40-454D-9816-B00C85E3E4E3}" dt="2025-12-03T14:28:14.577" v="115" actId="1036"/>
          <ac:spMkLst>
            <pc:docMk/>
            <pc:sldMk cId="846788600" sldId="259"/>
            <ac:spMk id="6" creationId="{F7EF079F-CEA4-AFE0-79B7-6D06F6A8D428}"/>
          </ac:spMkLst>
        </pc:spChg>
        <pc:spChg chg="add mod">
          <ac:chgData name="Brian Robinson" userId="0641c4c5-2f89-46b7-a1c0-255ee54644ae" providerId="ADAL" clId="{ED66AB01-BF40-454D-9816-B00C85E3E4E3}" dt="2025-12-03T14:21:20.684" v="82"/>
          <ac:spMkLst>
            <pc:docMk/>
            <pc:sldMk cId="846788600" sldId="259"/>
            <ac:spMk id="7" creationId="{49A099D7-EF3C-A5E3-2C50-B0B989EE2AA2}"/>
          </ac:spMkLst>
        </pc:spChg>
      </pc:sldChg>
      <pc:sldChg chg="modSp mod">
        <pc:chgData name="Brian Robinson" userId="0641c4c5-2f89-46b7-a1c0-255ee54644ae" providerId="ADAL" clId="{ED66AB01-BF40-454D-9816-B00C85E3E4E3}" dt="2025-12-03T14:22:00.974" v="93" actId="1076"/>
        <pc:sldMkLst>
          <pc:docMk/>
          <pc:sldMk cId="61792851" sldId="260"/>
        </pc:sldMkLst>
        <pc:spChg chg="mod">
          <ac:chgData name="Brian Robinson" userId="0641c4c5-2f89-46b7-a1c0-255ee54644ae" providerId="ADAL" clId="{ED66AB01-BF40-454D-9816-B00C85E3E4E3}" dt="2025-12-03T14:22:00.974" v="93" actId="1076"/>
          <ac:spMkLst>
            <pc:docMk/>
            <pc:sldMk cId="61792851" sldId="260"/>
            <ac:spMk id="4" creationId="{58E518B5-9232-C6F5-75B2-0BB56EAA1758}"/>
          </ac:spMkLst>
        </pc:spChg>
        <pc:spChg chg="mod">
          <ac:chgData name="Brian Robinson" userId="0641c4c5-2f89-46b7-a1c0-255ee54644ae" providerId="ADAL" clId="{ED66AB01-BF40-454D-9816-B00C85E3E4E3}" dt="2025-12-03T14:20:26.341" v="79" actId="20577"/>
          <ac:spMkLst>
            <pc:docMk/>
            <pc:sldMk cId="61792851" sldId="260"/>
            <ac:spMk id="5" creationId="{BC732F11-9C76-3E79-BA00-66C4293151F9}"/>
          </ac:spMkLst>
        </pc:spChg>
      </pc:sldChg>
      <pc:sldChg chg="modSp mod">
        <pc:chgData name="Brian Robinson" userId="0641c4c5-2f89-46b7-a1c0-255ee54644ae" providerId="ADAL" clId="{ED66AB01-BF40-454D-9816-B00C85E3E4E3}" dt="2025-12-03T15:26:03.122" v="220" actId="1036"/>
        <pc:sldMkLst>
          <pc:docMk/>
          <pc:sldMk cId="3991449731" sldId="261"/>
        </pc:sldMkLst>
        <pc:spChg chg="mod">
          <ac:chgData name="Brian Robinson" userId="0641c4c5-2f89-46b7-a1c0-255ee54644ae" providerId="ADAL" clId="{ED66AB01-BF40-454D-9816-B00C85E3E4E3}" dt="2025-12-03T15:26:03.122" v="220" actId="1036"/>
          <ac:spMkLst>
            <pc:docMk/>
            <pc:sldMk cId="3991449731" sldId="261"/>
            <ac:spMk id="2" creationId="{D734C2DE-DFF4-036A-0623-3394DB34C33F}"/>
          </ac:spMkLst>
        </pc:spChg>
        <pc:spChg chg="mod">
          <ac:chgData name="Brian Robinson" userId="0641c4c5-2f89-46b7-a1c0-255ee54644ae" providerId="ADAL" clId="{ED66AB01-BF40-454D-9816-B00C85E3E4E3}" dt="2025-12-03T15:26:00.771" v="217" actId="1036"/>
          <ac:spMkLst>
            <pc:docMk/>
            <pc:sldMk cId="3991449731" sldId="261"/>
            <ac:spMk id="3" creationId="{9972804B-BC7B-8520-7C8D-9E6D9649D6DD}"/>
          </ac:spMkLst>
        </pc:spChg>
        <pc:spChg chg="mod">
          <ac:chgData name="Brian Robinson" userId="0641c4c5-2f89-46b7-a1c0-255ee54644ae" providerId="ADAL" clId="{ED66AB01-BF40-454D-9816-B00C85E3E4E3}" dt="2025-12-03T14:34:58.848" v="195" actId="1035"/>
          <ac:spMkLst>
            <pc:docMk/>
            <pc:sldMk cId="3991449731" sldId="261"/>
            <ac:spMk id="4" creationId="{DBDDA440-BFAD-3CCF-5AD6-A4C11FA1A774}"/>
          </ac:spMkLst>
        </pc:spChg>
      </pc:sldChg>
      <pc:sldChg chg="modSp mod">
        <pc:chgData name="Brian Robinson" userId="0641c4c5-2f89-46b7-a1c0-255ee54644ae" providerId="ADAL" clId="{ED66AB01-BF40-454D-9816-B00C85E3E4E3}" dt="2025-12-03T14:24:02.031" v="103" actId="1076"/>
        <pc:sldMkLst>
          <pc:docMk/>
          <pc:sldMk cId="4099128719" sldId="262"/>
        </pc:sldMkLst>
        <pc:spChg chg="mod">
          <ac:chgData name="Brian Robinson" userId="0641c4c5-2f89-46b7-a1c0-255ee54644ae" providerId="ADAL" clId="{ED66AB01-BF40-454D-9816-B00C85E3E4E3}" dt="2025-12-03T14:24:02.031" v="103" actId="1076"/>
          <ac:spMkLst>
            <pc:docMk/>
            <pc:sldMk cId="4099128719" sldId="262"/>
            <ac:spMk id="4" creationId="{58E518B5-9232-C6F5-75B2-0BB56EAA1758}"/>
          </ac:spMkLst>
        </pc:spChg>
        <pc:spChg chg="mod">
          <ac:chgData name="Brian Robinson" userId="0641c4c5-2f89-46b7-a1c0-255ee54644ae" providerId="ADAL" clId="{ED66AB01-BF40-454D-9816-B00C85E3E4E3}" dt="2025-12-03T14:23:30.270" v="99" actId="6549"/>
          <ac:spMkLst>
            <pc:docMk/>
            <pc:sldMk cId="4099128719" sldId="262"/>
            <ac:spMk id="6" creationId="{9972804B-BC7B-8520-7C8D-9E6D9649D6DD}"/>
          </ac:spMkLst>
        </pc:spChg>
        <pc:picChg chg="mod">
          <ac:chgData name="Brian Robinson" userId="0641c4c5-2f89-46b7-a1c0-255ee54644ae" providerId="ADAL" clId="{ED66AB01-BF40-454D-9816-B00C85E3E4E3}" dt="2025-12-03T14:22:53.419" v="97" actId="1076"/>
          <ac:picMkLst>
            <pc:docMk/>
            <pc:sldMk cId="4099128719" sldId="262"/>
            <ac:picMk id="5" creationId="{00000000-0000-0000-0000-000000000000}"/>
          </ac:picMkLst>
        </pc:picChg>
      </pc:sldChg>
      <pc:sldChg chg="addSp modSp mod">
        <pc:chgData name="Brian Robinson" userId="0641c4c5-2f89-46b7-a1c0-255ee54644ae" providerId="ADAL" clId="{ED66AB01-BF40-454D-9816-B00C85E3E4E3}" dt="2025-12-03T14:29:31.355" v="131" actId="1076"/>
        <pc:sldMkLst>
          <pc:docMk/>
          <pc:sldMk cId="1383863878" sldId="263"/>
        </pc:sldMkLst>
        <pc:spChg chg="add mod">
          <ac:chgData name="Brian Robinson" userId="0641c4c5-2f89-46b7-a1c0-255ee54644ae" providerId="ADAL" clId="{ED66AB01-BF40-454D-9816-B00C85E3E4E3}" dt="2025-12-03T14:27:54.202" v="108"/>
          <ac:spMkLst>
            <pc:docMk/>
            <pc:sldMk cId="1383863878" sldId="263"/>
            <ac:spMk id="3" creationId="{F676DE10-1A93-B3CC-D30A-2CE504FC978E}"/>
          </ac:spMkLst>
        </pc:spChg>
        <pc:spChg chg="mod">
          <ac:chgData name="Brian Robinson" userId="0641c4c5-2f89-46b7-a1c0-255ee54644ae" providerId="ADAL" clId="{ED66AB01-BF40-454D-9816-B00C85E3E4E3}" dt="2025-12-03T14:28:41.050" v="124" actId="1038"/>
          <ac:spMkLst>
            <pc:docMk/>
            <pc:sldMk cId="1383863878" sldId="263"/>
            <ac:spMk id="4" creationId="{58E518B5-9232-C6F5-75B2-0BB56EAA1758}"/>
          </ac:spMkLst>
        </pc:spChg>
        <pc:spChg chg="mod">
          <ac:chgData name="Brian Robinson" userId="0641c4c5-2f89-46b7-a1c0-255ee54644ae" providerId="ADAL" clId="{ED66AB01-BF40-454D-9816-B00C85E3E4E3}" dt="2025-12-03T14:29:31.355" v="131" actId="1076"/>
          <ac:spMkLst>
            <pc:docMk/>
            <pc:sldMk cId="1383863878" sldId="263"/>
            <ac:spMk id="6" creationId="{9972804B-BC7B-8520-7C8D-9E6D9649D6DD}"/>
          </ac:spMkLst>
        </pc:spChg>
        <pc:picChg chg="mod">
          <ac:chgData name="Brian Robinson" userId="0641c4c5-2f89-46b7-a1c0-255ee54644ae" providerId="ADAL" clId="{ED66AB01-BF40-454D-9816-B00C85E3E4E3}" dt="2025-12-03T14:29:18.682" v="129" actId="1076"/>
          <ac:picMkLst>
            <pc:docMk/>
            <pc:sldMk cId="1383863878" sldId="263"/>
            <ac:picMk id="7" creationId="{00000000-0000-0000-0000-000000000000}"/>
          </ac:picMkLst>
        </pc:picChg>
      </pc:sldChg>
      <pc:sldChg chg="modSp mod">
        <pc:chgData name="Brian Robinson" userId="0641c4c5-2f89-46b7-a1c0-255ee54644ae" providerId="ADAL" clId="{ED66AB01-BF40-454D-9816-B00C85E3E4E3}" dt="2025-12-03T14:32:57.254" v="160" actId="1076"/>
        <pc:sldMkLst>
          <pc:docMk/>
          <pc:sldMk cId="3809885218" sldId="264"/>
        </pc:sldMkLst>
        <pc:spChg chg="mod">
          <ac:chgData name="Brian Robinson" userId="0641c4c5-2f89-46b7-a1c0-255ee54644ae" providerId="ADAL" clId="{ED66AB01-BF40-454D-9816-B00C85E3E4E3}" dt="2025-12-03T14:32:11.954" v="150" actId="20577"/>
          <ac:spMkLst>
            <pc:docMk/>
            <pc:sldMk cId="3809885218" sldId="264"/>
            <ac:spMk id="2" creationId="{D734C2DE-DFF4-036A-0623-3394DB34C33F}"/>
          </ac:spMkLst>
        </pc:spChg>
        <pc:spChg chg="mod">
          <ac:chgData name="Brian Robinson" userId="0641c4c5-2f89-46b7-a1c0-255ee54644ae" providerId="ADAL" clId="{ED66AB01-BF40-454D-9816-B00C85E3E4E3}" dt="2025-12-03T14:32:40.066" v="155" actId="20577"/>
          <ac:spMkLst>
            <pc:docMk/>
            <pc:sldMk cId="3809885218" sldId="264"/>
            <ac:spMk id="3" creationId="{9972804B-BC7B-8520-7C8D-9E6D9649D6DD}"/>
          </ac:spMkLst>
        </pc:spChg>
        <pc:spChg chg="mod">
          <ac:chgData name="Brian Robinson" userId="0641c4c5-2f89-46b7-a1c0-255ee54644ae" providerId="ADAL" clId="{ED66AB01-BF40-454D-9816-B00C85E3E4E3}" dt="2025-12-03T14:32:57.254" v="160" actId="1076"/>
          <ac:spMkLst>
            <pc:docMk/>
            <pc:sldMk cId="3809885218" sldId="264"/>
            <ac:spMk id="4" creationId="{DBDDA440-BFAD-3CCF-5AD6-A4C11FA1A774}"/>
          </ac:spMkLst>
        </pc:spChg>
      </pc:sldChg>
      <pc:sldChg chg="modSp mod">
        <pc:chgData name="Brian Robinson" userId="0641c4c5-2f89-46b7-a1c0-255ee54644ae" providerId="ADAL" clId="{ED66AB01-BF40-454D-9816-B00C85E3E4E3}" dt="2025-12-03T14:34:19.566" v="193" actId="1036"/>
        <pc:sldMkLst>
          <pc:docMk/>
          <pc:sldMk cId="48817138" sldId="265"/>
        </pc:sldMkLst>
        <pc:spChg chg="mod">
          <ac:chgData name="Brian Robinson" userId="0641c4c5-2f89-46b7-a1c0-255ee54644ae" providerId="ADAL" clId="{ED66AB01-BF40-454D-9816-B00C85E3E4E3}" dt="2025-12-03T14:32:19.114" v="153" actId="1076"/>
          <ac:spMkLst>
            <pc:docMk/>
            <pc:sldMk cId="48817138" sldId="265"/>
            <ac:spMk id="2" creationId="{D734C2DE-DFF4-036A-0623-3394DB34C33F}"/>
          </ac:spMkLst>
        </pc:spChg>
        <pc:spChg chg="mod">
          <ac:chgData name="Brian Robinson" userId="0641c4c5-2f89-46b7-a1c0-255ee54644ae" providerId="ADAL" clId="{ED66AB01-BF40-454D-9816-B00C85E3E4E3}" dt="2025-12-03T14:33:32.102" v="172" actId="20577"/>
          <ac:spMkLst>
            <pc:docMk/>
            <pc:sldMk cId="48817138" sldId="265"/>
            <ac:spMk id="3" creationId="{9972804B-BC7B-8520-7C8D-9E6D9649D6DD}"/>
          </ac:spMkLst>
        </pc:spChg>
        <pc:spChg chg="mod">
          <ac:chgData name="Brian Robinson" userId="0641c4c5-2f89-46b7-a1c0-255ee54644ae" providerId="ADAL" clId="{ED66AB01-BF40-454D-9816-B00C85E3E4E3}" dt="2025-12-03T14:34:19.566" v="193" actId="1036"/>
          <ac:spMkLst>
            <pc:docMk/>
            <pc:sldMk cId="48817138" sldId="265"/>
            <ac:spMk id="4" creationId="{DBDDA440-BFAD-3CCF-5AD6-A4C11FA1A774}"/>
          </ac:spMkLst>
        </pc:spChg>
        <pc:spChg chg="mod">
          <ac:chgData name="Brian Robinson" userId="0641c4c5-2f89-46b7-a1c0-255ee54644ae" providerId="ADAL" clId="{ED66AB01-BF40-454D-9816-B00C85E3E4E3}" dt="2025-12-03T14:33:10.368" v="161" actId="5793"/>
          <ac:spMkLst>
            <pc:docMk/>
            <pc:sldMk cId="48817138" sldId="265"/>
            <ac:spMk id="5" creationId="{2C9C66A4-9900-7A74-4396-E5239C7C6389}"/>
          </ac:spMkLst>
        </pc:spChg>
        <pc:spChg chg="mod">
          <ac:chgData name="Brian Robinson" userId="0641c4c5-2f89-46b7-a1c0-255ee54644ae" providerId="ADAL" clId="{ED66AB01-BF40-454D-9816-B00C85E3E4E3}" dt="2025-12-03T14:33:45.174" v="173" actId="1076"/>
          <ac:spMkLst>
            <pc:docMk/>
            <pc:sldMk cId="48817138" sldId="265"/>
            <ac:spMk id="8" creationId="{2C9C66A4-9900-7A74-4396-E5239C7C6389}"/>
          </ac:spMkLst>
        </pc:spChg>
        <pc:spChg chg="mod">
          <ac:chgData name="Brian Robinson" userId="0641c4c5-2f89-46b7-a1c0-255ee54644ae" providerId="ADAL" clId="{ED66AB01-BF40-454D-9816-B00C85E3E4E3}" dt="2025-12-03T14:34:07.785" v="182" actId="20577"/>
          <ac:spMkLst>
            <pc:docMk/>
            <pc:sldMk cId="48817138" sldId="265"/>
            <ac:spMk id="9" creationId="{9972804B-BC7B-8520-7C8D-9E6D9649D6D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484EE-1AFA-37AE-0DBB-9AE06E4323C1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1149178" y="2235200"/>
            <a:ext cx="10243752" cy="2387600"/>
          </a:xfrm>
        </p:spPr>
        <p:txBody>
          <a:bodyPr anchor="b">
            <a:normAutofit/>
          </a:bodyPr>
          <a:lstStyle>
            <a:lvl1pPr algn="r">
              <a:defRPr sz="540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tle of Journal Club Featur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4CDBF9-AE24-B1A3-9703-BA6F3EE632E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1149178" y="4714875"/>
            <a:ext cx="10243752" cy="1204740"/>
          </a:xfrm>
        </p:spPr>
        <p:txBody>
          <a:bodyPr/>
          <a:lstStyle>
            <a:lvl1pPr marL="0" indent="0" algn="r">
              <a:buNone/>
              <a:defRPr sz="24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uthor(s) </a:t>
            </a:r>
            <a:r>
              <a:rPr lang="en-US"/>
              <a:t>of journal </a:t>
            </a:r>
            <a:r>
              <a:rPr lang="en-US" dirty="0"/>
              <a:t>club materials</a:t>
            </a:r>
          </a:p>
        </p:txBody>
      </p:sp>
    </p:spTree>
    <p:extLst>
      <p:ext uri="{BB962C8B-B14F-4D97-AF65-F5344CB8AC3E}">
        <p14:creationId xmlns:p14="http://schemas.microsoft.com/office/powerpoint/2010/main" val="2197976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26CAB3-D7F9-CD46-7A75-4ECC353AE8F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28135" y="1581674"/>
            <a:ext cx="11073714" cy="936901"/>
          </a:xfrm>
        </p:spPr>
        <p:txBody>
          <a:bodyPr/>
          <a:lstStyle/>
          <a:p>
            <a:r>
              <a:rPr lang="en-US" dirty="0"/>
              <a:t>Backgr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36C866-60DA-3E92-9A04-72D65FC80DAB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28135" y="2632284"/>
            <a:ext cx="11073714" cy="3527806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dirty="0"/>
              <a:t>Short summary of the purpose of </a:t>
            </a:r>
            <a:r>
              <a:rPr lang="en-US"/>
              <a:t>the article. Include any key prior studies that informed or led to this work, along with citations</a:t>
            </a:r>
          </a:p>
          <a:p>
            <a:pPr lvl="0"/>
            <a:endParaRPr lang="en-US" dirty="0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162F113-14A5-93CA-018A-018B7888E2C2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2325852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etho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Methods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4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lvl="0"/>
            <a:r>
              <a:rPr lang="en-US" dirty="0"/>
              <a:t>Brief summary of the data source, study design (e.g. randomized trial, observational cohort study, cross-sectional study), and any aspects of analysis or statistical methods that are important to understanding the study (including why these methods were chosen to answer this question)</a:t>
            </a:r>
          </a:p>
        </p:txBody>
      </p:sp>
      <p:sp>
        <p:nvSpPr>
          <p:cNvPr id="9" name="Text Placeholder 7">
            <a:extLst>
              <a:ext uri="{FF2B5EF4-FFF2-40B4-BE49-F238E27FC236}">
                <a16:creationId xmlns:a16="http://schemas.microsoft.com/office/drawing/2014/main" id="{EFD5A073-AD13-5D77-451D-FE4D472EE441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80599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sul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Results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4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dirty="0"/>
              <a:t>Key table(s) and figure(s) along with bullet points with </a:t>
            </a:r>
            <a:r>
              <a:rPr lang="en-US"/>
              <a:t>key findings. (If you need an additional slide, please duplicate this slide)</a:t>
            </a:r>
          </a:p>
          <a:p>
            <a:pPr lvl="0"/>
            <a:endParaRPr lang="en-US" dirty="0"/>
          </a:p>
        </p:txBody>
      </p:sp>
      <p:sp>
        <p:nvSpPr>
          <p:cNvPr id="2" name="Text Placeholder 7">
            <a:extLst>
              <a:ext uri="{FF2B5EF4-FFF2-40B4-BE49-F238E27FC236}">
                <a16:creationId xmlns:a16="http://schemas.microsoft.com/office/drawing/2014/main" id="{F0BB15E5-B5B2-5635-5CE7-88D5AD839AC2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3510468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scuss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Discussion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5"/>
            <a:ext cx="11071654" cy="16705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lvl="0"/>
            <a:r>
              <a:rPr lang="en-US" dirty="0"/>
              <a:t>Strengths and weaknesses to consider, including generalizability, potential biases, potential for confounding</a:t>
            </a:r>
          </a:p>
          <a:p>
            <a:pPr lvl="0"/>
            <a:endParaRPr lang="en-US" dirty="0"/>
          </a:p>
        </p:txBody>
      </p:sp>
      <p:sp>
        <p:nvSpPr>
          <p:cNvPr id="2" name="Text Placeholder 7">
            <a:extLst>
              <a:ext uri="{FF2B5EF4-FFF2-40B4-BE49-F238E27FC236}">
                <a16:creationId xmlns:a16="http://schemas.microsoft.com/office/drawing/2014/main" id="{74F97A62-F9D7-F04E-930C-AD37311B155F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1359233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15265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8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537520-D36E-B475-A8EC-7BB4AE348D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81" y="162739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1701BA-94E3-525E-7C81-CFF551A73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5481" y="2650572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24578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60" r:id="rId4"/>
    <p:sldLayoutId id="2147483661" r:id="rId5"/>
    <p:sldLayoutId id="2147483662" r:id="rId6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1" i="0" kern="1200" spc="-150">
          <a:solidFill>
            <a:srgbClr val="7030A0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02/acr.25682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8A319-0C10-171B-BB90-693E0C4557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99071" y="2143125"/>
            <a:ext cx="10593474" cy="2571750"/>
          </a:xfrm>
        </p:spPr>
        <p:txBody>
          <a:bodyPr>
            <a:normAutofit/>
          </a:bodyPr>
          <a:lstStyle/>
          <a:p>
            <a:r>
              <a:rPr lang="en-US" sz="4400"/>
              <a:t>Clinical Conditions Associated With a High Antinuclear Antibody </a:t>
            </a:r>
            <a:r>
              <a:rPr lang="en-US" sz="4400" dirty="0"/>
              <a:t>T</a:t>
            </a:r>
            <a:r>
              <a:rPr lang="en-US" sz="4400"/>
              <a:t>iter in Individuals Without Autoimmune Disease</a:t>
            </a:r>
            <a:endParaRPr lang="en-US" sz="4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1E4767-9584-5800-2001-4B5E799DCE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40774" y="4714875"/>
            <a:ext cx="10852156" cy="1111993"/>
          </a:xfrm>
        </p:spPr>
        <p:txBody>
          <a:bodyPr>
            <a:normAutofit/>
          </a:bodyPr>
          <a:lstStyle/>
          <a:p>
            <a:r>
              <a:rPr lang="en-US" sz="2000" dirty="0"/>
              <a:t>Matthew Chung, BS</a:t>
            </a:r>
            <a:r>
              <a:rPr lang="en-US" sz="2000"/>
              <a:t>; John </a:t>
            </a:r>
            <a:r>
              <a:rPr lang="en-US" sz="2000" dirty="0"/>
              <a:t>P. Shelley, PhD; Gul Karakoc, MSc; John Still, BA; Xiaodi Ruan, MSc; Jonathan Mosley, MD, PhD; C. Michael Stein </a:t>
            </a:r>
            <a:r>
              <a:rPr lang="en-US" sz="2000" dirty="0" err="1"/>
              <a:t>MBChB</a:t>
            </a:r>
            <a:r>
              <a:rPr lang="en-US" sz="2000" dirty="0"/>
              <a:t>, MRCP; Vivian K. Kawai MD, MPH</a:t>
            </a:r>
          </a:p>
        </p:txBody>
      </p:sp>
      <p:sp>
        <p:nvSpPr>
          <p:cNvPr id="5" name="Text Placeholder 4">
            <a:hlinkClick r:id="rId2"/>
            <a:extLst>
              <a:ext uri="{FF2B5EF4-FFF2-40B4-BE49-F238E27FC236}">
                <a16:creationId xmlns:a16="http://schemas.microsoft.com/office/drawing/2014/main" id="{DFFB3F8F-A8BF-C626-C958-83749942F071}"/>
              </a:ext>
            </a:extLst>
          </p:cNvPr>
          <p:cNvSpPr txBox="1">
            <a:spLocks/>
          </p:cNvSpPr>
          <p:nvPr/>
        </p:nvSpPr>
        <p:spPr>
          <a:xfrm>
            <a:off x="1148406" y="5918943"/>
            <a:ext cx="10244138" cy="75423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buFont typeface="Arial" panose="020B0604020202020204" pitchFamily="34" charset="0"/>
              <a:buNone/>
              <a:defRPr sz="1200" kern="120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US" sz="1400" dirty="0"/>
              <a:t>A feature designed to facilitate discussion of published research. This journal club accompanies the below article:</a:t>
            </a:r>
          </a:p>
          <a:p>
            <a:r>
              <a:rPr lang="en-US" dirty="0"/>
              <a:t>Chung M, Shelley JP, Karakoc G, et al. Clinical conditions associated with a high antinuclear antibody titer in individuals without an autoimmune disease. Arthritis Care Res (Hoboken) 2025</a:t>
            </a:r>
            <a:r>
              <a:rPr lang="en-US"/>
              <a:t>. https://doi.org/10.1002/acr.2568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248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11B74-DB9C-2DE8-107A-032556819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7749" y="1455353"/>
            <a:ext cx="11073714" cy="936901"/>
          </a:xfrm>
        </p:spPr>
        <p:txBody>
          <a:bodyPr/>
          <a:lstStyle/>
          <a:p>
            <a:r>
              <a:rPr lang="en-US" dirty="0"/>
              <a:t>Backgr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88CA69-584E-36DF-2777-F5810BAB28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7749" y="2537925"/>
            <a:ext cx="11073714" cy="3371385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Antinuclear antibodies (ANAs) are common in autoimmune (AI) disorders, including systemic lupus erythematosus.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A positive ANA test also appears in 12-30% of the general population, with 2% of these at high titers.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High-titer ANAs are typically seen as more indicative of AI disease, but their significance in people without AI disease remains unclear.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Tested hypothesis </a:t>
            </a:r>
            <a:r>
              <a:rPr lang="en-US" sz="2200"/>
              <a:t>→ high </a:t>
            </a:r>
            <a:r>
              <a:rPr lang="en-US" sz="2200" dirty="0"/>
              <a:t>ANA titer in individuals without AI disease is associated with altered disease risk.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B15881-F131-FDEF-D1CC-4E88BB65AA5D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42450" y="6354050"/>
            <a:ext cx="11268845" cy="45478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1100" dirty="0"/>
              <a:t>Chung M, Shelley JP, Karakoc G, et al. Clinical conditions associated with a high antinuclear antibody titer in individuals without an autoimmune disease. Arthritis Care Res (Hoboken</a:t>
            </a:r>
            <a:r>
              <a:rPr lang="en-US" sz="1100"/>
              <a:t>) 2025. https://doi.org/10.1002/acr.25682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916643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7DA40-E0DF-460C-1B26-E792F9851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4350" y="1340996"/>
            <a:ext cx="11187113" cy="936901"/>
          </a:xfrm>
        </p:spPr>
        <p:txBody>
          <a:bodyPr/>
          <a:lstStyle/>
          <a:p>
            <a:r>
              <a:rPr lang="en-US" dirty="0"/>
              <a:t>Metho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966EE5-E4C1-854A-7562-C7CFB9E302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4350" y="2277897"/>
            <a:ext cx="11487150" cy="3887344"/>
          </a:xfrm>
        </p:spPr>
        <p:txBody>
          <a:bodyPr>
            <a:normAutofit fontScale="85000" lnSpcReduction="10000"/>
          </a:bodyPr>
          <a:lstStyle/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/>
              <a:t>Retrospective case–control </a:t>
            </a:r>
            <a:r>
              <a:rPr lang="en-US" dirty="0"/>
              <a:t>study in the Vanderbilt University Medical Center’s de-identified electronic medical record (EMR) system.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Individuals ≥18 years old with ANA testing as part of clinical care were included; those </a:t>
            </a:r>
            <a:r>
              <a:rPr lang="en-US"/>
              <a:t>with AI </a:t>
            </a:r>
            <a:r>
              <a:rPr lang="en-US" dirty="0"/>
              <a:t>diseases were excluded.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3 exclusive groups: a) high titer (HT): ANA≥1:640, b) low titer (LT): ANA≤1:80, and c) negative ANA (NG)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Prevalence of clinical diagnoses recorded in the EMR within (±) 90 days of the ANA test were compared using a phenome-wide association study (</a:t>
            </a:r>
            <a:r>
              <a:rPr lang="en-US" dirty="0" err="1"/>
              <a:t>PheWAS</a:t>
            </a:r>
            <a:r>
              <a:rPr lang="en-US" dirty="0"/>
              <a:t>) approach where ≥2 </a:t>
            </a:r>
            <a:r>
              <a:rPr lang="en-US" dirty="0" err="1"/>
              <a:t>phecodes</a:t>
            </a:r>
            <a:r>
              <a:rPr lang="en-US" dirty="0"/>
              <a:t> at different dates </a:t>
            </a:r>
            <a:r>
              <a:rPr lang="en-US"/>
              <a:t>were used </a:t>
            </a:r>
            <a:r>
              <a:rPr lang="en-US" dirty="0"/>
              <a:t>for </a:t>
            </a:r>
            <a:r>
              <a:rPr lang="en-US"/>
              <a:t>case definition </a:t>
            </a:r>
            <a:r>
              <a:rPr lang="en-US" dirty="0"/>
              <a:t>and controls did not have a closely related </a:t>
            </a:r>
            <a:r>
              <a:rPr lang="en-US" dirty="0" err="1"/>
              <a:t>phecode</a:t>
            </a:r>
            <a:r>
              <a:rPr lang="en-US" dirty="0"/>
              <a:t>.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ja-JP" dirty="0">
                <a:ea typeface="ＭＳ Ｐゴシック" panose="020B0600070205080204" pitchFamily="34" charset="-128"/>
              </a:rPr>
              <a:t>Analyses were adjusted for age at ANA testing, sex, median body mass index, and reported race</a:t>
            </a:r>
            <a:r>
              <a:rPr lang="en-US" dirty="0"/>
              <a:t>.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F7EF079F-CEA4-AFE0-79B7-6D06F6A8D42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71302"/>
            <a:ext cx="11072813" cy="405069"/>
          </a:xfrm>
        </p:spPr>
        <p:txBody>
          <a:bodyPr>
            <a:normAutofit/>
          </a:bodyPr>
          <a:lstStyle/>
          <a:p>
            <a:r>
              <a:rPr lang="en-US" sz="1100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</p:spTree>
    <p:extLst>
      <p:ext uri="{BB962C8B-B14F-4D97-AF65-F5344CB8AC3E}">
        <p14:creationId xmlns:p14="http://schemas.microsoft.com/office/powerpoint/2010/main" val="8467886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94899-5F70-89D8-064D-ED338F694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5281" y="1345914"/>
            <a:ext cx="4823769" cy="936901"/>
          </a:xfrm>
        </p:spPr>
        <p:txBody>
          <a:bodyPr/>
          <a:lstStyle/>
          <a:p>
            <a:r>
              <a:rPr lang="en-US" dirty="0"/>
              <a:t>Results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518B5-9232-C6F5-75B2-0BB56EAA175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86697" y="6418612"/>
            <a:ext cx="11218606" cy="439388"/>
          </a:xfrm>
        </p:spPr>
        <p:txBody>
          <a:bodyPr>
            <a:normAutofit/>
          </a:bodyPr>
          <a:lstStyle/>
          <a:p>
            <a:r>
              <a:rPr lang="en-US" sz="1100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BC732F11-9C76-3E79-BA00-66C4293151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05057" y="2362275"/>
            <a:ext cx="4286559" cy="3490447"/>
          </a:xfrm>
        </p:spPr>
        <p:txBody>
          <a:bodyPr vert="horz" lIns="91440" tIns="45720" rIns="91440" bIns="45720" rtlCol="0"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>
                <a:latin typeface="Arial"/>
                <a:cs typeface="Arial"/>
              </a:rPr>
              <a:t>28,781 individuals were </a:t>
            </a:r>
            <a:r>
              <a:rPr lang="en-US" sz="2200">
                <a:latin typeface="Arial"/>
                <a:cs typeface="Arial"/>
              </a:rPr>
              <a:t>eligible: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200">
                <a:latin typeface="Arial"/>
                <a:cs typeface="Arial"/>
              </a:rPr>
              <a:t>3.1</a:t>
            </a:r>
            <a:r>
              <a:rPr lang="en-US" sz="2200" dirty="0">
                <a:latin typeface="Arial"/>
                <a:cs typeface="Arial"/>
              </a:rPr>
              <a:t>% </a:t>
            </a:r>
            <a:r>
              <a:rPr lang="en-US" sz="2200">
                <a:latin typeface="Arial"/>
                <a:cs typeface="Arial"/>
              </a:rPr>
              <a:t>in HT group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200">
                <a:latin typeface="Arial"/>
                <a:cs typeface="Arial"/>
              </a:rPr>
              <a:t>12.3</a:t>
            </a:r>
            <a:r>
              <a:rPr lang="en-US" sz="2200" dirty="0">
                <a:latin typeface="Arial"/>
                <a:cs typeface="Arial"/>
              </a:rPr>
              <a:t>% </a:t>
            </a:r>
            <a:r>
              <a:rPr lang="en-US" sz="2200">
                <a:latin typeface="Arial"/>
                <a:cs typeface="Arial"/>
              </a:rPr>
              <a:t>in LT group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200">
                <a:latin typeface="Arial"/>
                <a:cs typeface="Arial"/>
              </a:rPr>
              <a:t>84.6</a:t>
            </a:r>
            <a:r>
              <a:rPr lang="en-US" sz="2200" dirty="0">
                <a:latin typeface="Arial"/>
                <a:cs typeface="Arial"/>
              </a:rPr>
              <a:t>% in </a:t>
            </a:r>
            <a:r>
              <a:rPr lang="en-US" sz="2200">
                <a:latin typeface="Arial"/>
                <a:cs typeface="Arial"/>
              </a:rPr>
              <a:t>HG group</a:t>
            </a:r>
            <a:endParaRPr lang="en-US" sz="22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endParaRPr lang="en-US" sz="2200" dirty="0">
              <a:latin typeface="Arial"/>
              <a:cs typeface="Arial"/>
            </a:endParaRPr>
          </a:p>
          <a:p>
            <a:pPr>
              <a:lnSpc>
                <a:spcPct val="80000"/>
              </a:lnSpc>
              <a:spcBef>
                <a:spcPts val="400"/>
              </a:spcBef>
              <a:spcAft>
                <a:spcPts val="400"/>
              </a:spcAft>
            </a:pPr>
            <a:endParaRPr lang="en-US" sz="2200" dirty="0"/>
          </a:p>
          <a:p>
            <a:pPr>
              <a:lnSpc>
                <a:spcPct val="80000"/>
              </a:lnSpc>
              <a:spcBef>
                <a:spcPts val="300"/>
              </a:spcBef>
              <a:spcAft>
                <a:spcPts val="300"/>
              </a:spcAft>
            </a:pPr>
            <a:endParaRPr lang="en-US" sz="1600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0886868"/>
              </p:ext>
            </p:extLst>
          </p:nvPr>
        </p:nvGraphicFramePr>
        <p:xfrm>
          <a:off x="5097780" y="1383030"/>
          <a:ext cx="6744175" cy="5035582"/>
        </p:xfrm>
        <a:graphic>
          <a:graphicData uri="http://schemas.openxmlformats.org/drawingml/2006/table">
            <a:tbl>
              <a:tblPr firstRow="1" firstCol="1" bandRow="1"/>
              <a:tblGrid>
                <a:gridCol w="2018603">
                  <a:extLst>
                    <a:ext uri="{9D8B030D-6E8A-4147-A177-3AD203B41FA5}">
                      <a16:colId xmlns:a16="http://schemas.microsoft.com/office/drawing/2014/main" val="145234200"/>
                    </a:ext>
                  </a:extLst>
                </a:gridCol>
                <a:gridCol w="1591151">
                  <a:extLst>
                    <a:ext uri="{9D8B030D-6E8A-4147-A177-3AD203B41FA5}">
                      <a16:colId xmlns:a16="http://schemas.microsoft.com/office/drawing/2014/main" val="2573458639"/>
                    </a:ext>
                  </a:extLst>
                </a:gridCol>
                <a:gridCol w="1566864">
                  <a:extLst>
                    <a:ext uri="{9D8B030D-6E8A-4147-A177-3AD203B41FA5}">
                      <a16:colId xmlns:a16="http://schemas.microsoft.com/office/drawing/2014/main" val="2062368807"/>
                    </a:ext>
                  </a:extLst>
                </a:gridCol>
                <a:gridCol w="1567557">
                  <a:extLst>
                    <a:ext uri="{9D8B030D-6E8A-4147-A177-3AD203B41FA5}">
                      <a16:colId xmlns:a16="http://schemas.microsoft.com/office/drawing/2014/main" val="3114983301"/>
                    </a:ext>
                  </a:extLst>
                </a:gridCol>
              </a:tblGrid>
              <a:tr h="462264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able 1: Characteristics of study population categorized by their antinuclear antibody result </a:t>
                      </a:r>
                      <a:endParaRPr lang="en-US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6705509"/>
                  </a:ext>
                </a:extLst>
              </a:tr>
              <a:tr h="46226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haracteristics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gative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=24,354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w tite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=3,544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 Tite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=883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593029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 at testing (years)*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5.0 [33.0, 56.0]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8.0 [37.0, 60.0]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5.0 [42.0, 66.0]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468331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emale (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,912 (65.3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577 (72.7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3 (69.4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748688"/>
                  </a:ext>
                </a:extLst>
              </a:tr>
              <a:tr h="46226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ody mass index (kg/m2)*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.2 [24.1, 33.4]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.1 [24.2, 33.3]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.7 [24.5, 33.3]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7473805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ported race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7723723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hite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7,779 (73.0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643 (74.6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96 (67.5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3231538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lack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,633 (10.8% 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6 (9.2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5 (9.6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638029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sia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42 (1.8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2 (1.4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 (1.3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760605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spanic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7 (2.5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7 (2.2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 (1.7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877954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ther/Unknown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83 (11.8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46 (12.6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76 (19.9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9386934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A pattern†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=830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=846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5210537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omogeneous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76 (57.3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78 (56.5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2459873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eckled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9 (37.2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9 (38.9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8868419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ucleolar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2 (5.1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 (3.3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2921643"/>
                  </a:ext>
                </a:extLst>
              </a:tr>
              <a:tr h="22590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thers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0.4%)</a:t>
                      </a:r>
                      <a:endParaRPr lang="en-US" sz="14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 (1.3%)</a:t>
                      </a:r>
                      <a:endParaRPr lang="en-US" sz="14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8379754"/>
                  </a:ext>
                </a:extLst>
              </a:tr>
              <a:tr h="664066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*Age at testing and body mass index are shown as median [interquartile range]; †antinuclear antibody (ANA) patterns were present in 23% and 95.8% of patients in the low (ANA titer≤1:80) and high titer (ANA titer≥1:640) groups, respectively. EMR: electronic medical record</a:t>
                      </a:r>
                      <a:endParaRPr lang="en-US" sz="12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44" marR="5404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87047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792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94899-5F70-89D8-064D-ED338F694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7821" y="1240171"/>
            <a:ext cx="3395019" cy="936901"/>
          </a:xfrm>
        </p:spPr>
        <p:txBody>
          <a:bodyPr/>
          <a:lstStyle/>
          <a:p>
            <a:r>
              <a:rPr lang="en-US" dirty="0"/>
              <a:t>Results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069"/>
          <a:stretch/>
        </p:blipFill>
        <p:spPr>
          <a:xfrm>
            <a:off x="5619749" y="1405671"/>
            <a:ext cx="6515100" cy="5024919"/>
          </a:xfrm>
        </p:spPr>
      </p:pic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518B5-9232-C6F5-75B2-0BB56EAA175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65355" y="6453559"/>
            <a:ext cx="11061290" cy="404441"/>
          </a:xfrm>
        </p:spPr>
        <p:txBody>
          <a:bodyPr>
            <a:normAutofit/>
          </a:bodyPr>
          <a:lstStyle/>
          <a:p>
            <a:r>
              <a:rPr lang="en-US" sz="1100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 txBox="1">
            <a:spLocks/>
          </p:cNvSpPr>
          <p:nvPr/>
        </p:nvSpPr>
        <p:spPr>
          <a:xfrm>
            <a:off x="376880" y="2142517"/>
            <a:ext cx="5242869" cy="3939306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u="sng" dirty="0"/>
              <a:t>HT versus LT</a:t>
            </a:r>
            <a:r>
              <a:rPr lang="en-US" dirty="0"/>
              <a:t>: 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Increased risk of 46 clinical diagnoses 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Top associations: chronic liver disease, non-alcoholic fatty liver disease or </a:t>
            </a:r>
            <a:r>
              <a:rPr lang="en-US" dirty="0" err="1"/>
              <a:t>steatohepatitis</a:t>
            </a:r>
            <a:r>
              <a:rPr lang="en-US" dirty="0"/>
              <a:t>, </a:t>
            </a:r>
            <a:r>
              <a:rPr lang="en-US"/>
              <a:t>and alcohol-related </a:t>
            </a:r>
            <a:r>
              <a:rPr lang="en-US" dirty="0"/>
              <a:t>liver disease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Increased risk of other </a:t>
            </a:r>
            <a:r>
              <a:rPr lang="en-US" dirty="0" err="1"/>
              <a:t>phecodes</a:t>
            </a:r>
            <a:r>
              <a:rPr lang="en-US" dirty="0"/>
              <a:t> related to liver disease and complications </a:t>
            </a:r>
          </a:p>
        </p:txBody>
      </p:sp>
    </p:spTree>
    <p:extLst>
      <p:ext uri="{BB962C8B-B14F-4D97-AF65-F5344CB8AC3E}">
        <p14:creationId xmlns:p14="http://schemas.microsoft.com/office/powerpoint/2010/main" val="40991287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94899-5F70-89D8-064D-ED338F694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156" y="1242772"/>
            <a:ext cx="3395019" cy="936901"/>
          </a:xfrm>
        </p:spPr>
        <p:txBody>
          <a:bodyPr/>
          <a:lstStyle/>
          <a:p>
            <a:r>
              <a:rPr lang="en-US" dirty="0"/>
              <a:t>Results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518B5-9232-C6F5-75B2-0BB56EAA175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553615" y="6453559"/>
            <a:ext cx="11163425" cy="404441"/>
          </a:xfrm>
        </p:spPr>
        <p:txBody>
          <a:bodyPr>
            <a:normAutofit/>
          </a:bodyPr>
          <a:lstStyle/>
          <a:p>
            <a:r>
              <a:rPr lang="en-US" sz="1100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 txBox="1">
            <a:spLocks/>
          </p:cNvSpPr>
          <p:nvPr/>
        </p:nvSpPr>
        <p:spPr>
          <a:xfrm>
            <a:off x="218027" y="2179673"/>
            <a:ext cx="5233345" cy="4162760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u="sng" dirty="0"/>
              <a:t>HT versus NG</a:t>
            </a:r>
            <a:r>
              <a:rPr lang="en-US" dirty="0"/>
              <a:t>: 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I</a:t>
            </a:r>
            <a:r>
              <a:rPr lang="en-US"/>
              <a:t>ncreased </a:t>
            </a:r>
            <a:r>
              <a:rPr lang="en-US" dirty="0"/>
              <a:t>risk of 67 clinical diagnoses 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Similar or closely related </a:t>
            </a:r>
            <a:r>
              <a:rPr lang="en-US" dirty="0" err="1"/>
              <a:t>phecodes</a:t>
            </a:r>
            <a:r>
              <a:rPr lang="en-US" dirty="0"/>
              <a:t> (59) as previous </a:t>
            </a:r>
            <a:r>
              <a:rPr lang="en-US" dirty="0" err="1"/>
              <a:t>PheWAS</a:t>
            </a:r>
            <a:endParaRPr lang="en-US" dirty="0"/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Top associations were </a:t>
            </a:r>
            <a:r>
              <a:rPr lang="en-US"/>
              <a:t>also liver- </a:t>
            </a:r>
            <a:r>
              <a:rPr lang="en-US" dirty="0"/>
              <a:t>related disorders</a:t>
            </a:r>
          </a:p>
          <a:p>
            <a:pPr marL="0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u="sng" dirty="0"/>
              <a:t>Case validation – chart review</a:t>
            </a:r>
            <a:r>
              <a:rPr lang="en-US" dirty="0"/>
              <a:t>: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/>
              <a:t>PPV </a:t>
            </a:r>
            <a:r>
              <a:rPr lang="en-US" dirty="0"/>
              <a:t>of 88% for diagnostic of non-AI liver disease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endParaRPr lang="en-US" sz="22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806"/>
          <a:stretch/>
        </p:blipFill>
        <p:spPr>
          <a:xfrm>
            <a:off x="5310234" y="1331336"/>
            <a:ext cx="6762061" cy="5122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38638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4C2DE-DFF4-036A-0623-3394DB34C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1655" y="1231026"/>
            <a:ext cx="11071654" cy="936901"/>
          </a:xfrm>
        </p:spPr>
        <p:txBody>
          <a:bodyPr/>
          <a:lstStyle/>
          <a:p>
            <a:r>
              <a:rPr lang="en-US" dirty="0"/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0029" y="2062841"/>
            <a:ext cx="11689235" cy="4460049"/>
          </a:xfrm>
        </p:spPr>
        <p:txBody>
          <a:bodyPr>
            <a:noAutofit/>
          </a:bodyPr>
          <a:lstStyle/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100" b="1" dirty="0"/>
              <a:t>Key findings</a:t>
            </a:r>
            <a:r>
              <a:rPr lang="en-US" sz="2100" dirty="0"/>
              <a:t>:</a:t>
            </a:r>
          </a:p>
          <a:p>
            <a:pPr lvl="1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US" sz="2100" dirty="0"/>
              <a:t>High ANA titer is strongly associated </a:t>
            </a:r>
            <a:r>
              <a:rPr lang="en-US" sz="2100"/>
              <a:t>with non-autoimmune liver-related disorders, including </a:t>
            </a:r>
            <a:r>
              <a:rPr lang="en-US" sz="2100" dirty="0"/>
              <a:t>non-alcoholic and alcoholic </a:t>
            </a:r>
            <a:r>
              <a:rPr lang="en-US" sz="2100"/>
              <a:t>liver disease.</a:t>
            </a:r>
            <a:endParaRPr lang="en-US" sz="2100" dirty="0"/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100" b="1" dirty="0"/>
              <a:t>Strengths</a:t>
            </a:r>
            <a:r>
              <a:rPr lang="en-US" sz="2100" dirty="0"/>
              <a:t>: real-world clinical data from a large teaching hospital, patients with autoimmune disease and prevalent diagnoses outside 90 days of the ANA test were excluded to avoid prevalent diagnoses, top associations were validated through </a:t>
            </a:r>
            <a:r>
              <a:rPr lang="en-US" sz="2100"/>
              <a:t>chart review.</a:t>
            </a:r>
            <a:endParaRPr lang="en-US" sz="2100" dirty="0"/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100" b="1" dirty="0"/>
              <a:t>Limitations</a:t>
            </a:r>
            <a:r>
              <a:rPr lang="en-US" sz="2100" dirty="0"/>
              <a:t>: risk of misclassification, potential of developing an autoimmune disease later, patients seen in a tertiary care hospital, and anti-DFS70 antibodies were not studied.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100" b="1" dirty="0"/>
              <a:t>Clinical implications</a:t>
            </a:r>
            <a:r>
              <a:rPr lang="en-US" sz="2100" dirty="0"/>
              <a:t>: non-autoimmune liver disease should be considered in differential diagnosis in the presence of a high ANA titer (ANA≥1:640).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DDA440-BFAD-3CCF-5AD6-A4C11FA1A77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81655" y="6477017"/>
            <a:ext cx="10913933" cy="375258"/>
          </a:xfrm>
        </p:spPr>
        <p:txBody>
          <a:bodyPr>
            <a:normAutofit fontScale="92500" lnSpcReduction="10000"/>
          </a:bodyPr>
          <a:lstStyle/>
          <a:p>
            <a:r>
              <a:rPr lang="en-US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</p:spTree>
    <p:extLst>
      <p:ext uri="{BB962C8B-B14F-4D97-AF65-F5344CB8AC3E}">
        <p14:creationId xmlns:p14="http://schemas.microsoft.com/office/powerpoint/2010/main" val="39914497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4C2DE-DFF4-036A-0623-3394DB34C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1656" y="1391174"/>
            <a:ext cx="11071654" cy="936901"/>
          </a:xfrm>
        </p:spPr>
        <p:txBody>
          <a:bodyPr/>
          <a:lstStyle/>
          <a:p>
            <a:r>
              <a:rPr lang="en-US"/>
              <a:t>Discussion Question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26925" y="3086003"/>
            <a:ext cx="10299130" cy="2945731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High ANA titer was associated with increased risk of liver disease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200" dirty="0"/>
              <a:t> Is this a marker or does ANA play a role in non-autoimmune </a:t>
            </a:r>
            <a:r>
              <a:rPr lang="en-US" sz="2200"/>
              <a:t>liver disease?</a:t>
            </a:r>
            <a:endParaRPr lang="en-US" sz="2200" dirty="0"/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200" dirty="0"/>
              <a:t> What is the evidence and the mechanism supporting </a:t>
            </a:r>
            <a:r>
              <a:rPr lang="en-US" sz="2200"/>
              <a:t>each scenario?</a:t>
            </a:r>
            <a:endParaRPr lang="en-US" sz="2200" dirty="0"/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200" dirty="0"/>
              <a:t>High ANA titer was also associated with increased risk of metabolic disorders 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200" dirty="0"/>
              <a:t> What are the potential mechanisms that explain these associations?</a:t>
            </a:r>
          </a:p>
          <a:p>
            <a:pPr marL="457200" lvl="1" inden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DDA440-BFAD-3CCF-5AD6-A4C11FA1A77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81656" y="6401114"/>
            <a:ext cx="10982633" cy="375258"/>
          </a:xfrm>
        </p:spPr>
        <p:txBody>
          <a:bodyPr>
            <a:normAutofit fontScale="92500" lnSpcReduction="10000"/>
          </a:bodyPr>
          <a:lstStyle/>
          <a:p>
            <a:r>
              <a:rPr lang="en-US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  <p:sp>
        <p:nvSpPr>
          <p:cNvPr id="5" name="Text Placeholder 2">
            <a:extLst>
              <a:ext uri="{FF2B5EF4-FFF2-40B4-BE49-F238E27FC236}">
                <a16:creationId xmlns:a16="http://schemas.microsoft.com/office/drawing/2014/main" id="{2C9C66A4-9900-7A74-4396-E5239C7C6389}"/>
              </a:ext>
            </a:extLst>
          </p:cNvPr>
          <p:cNvSpPr txBox="1">
            <a:spLocks/>
          </p:cNvSpPr>
          <p:nvPr/>
        </p:nvSpPr>
        <p:spPr>
          <a:xfrm>
            <a:off x="481656" y="2437094"/>
            <a:ext cx="11071654" cy="4617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b="1" i="1" dirty="0"/>
              <a:t>Findings</a:t>
            </a:r>
          </a:p>
        </p:txBody>
      </p:sp>
    </p:spTree>
    <p:extLst>
      <p:ext uri="{BB962C8B-B14F-4D97-AF65-F5344CB8AC3E}">
        <p14:creationId xmlns:p14="http://schemas.microsoft.com/office/powerpoint/2010/main" val="38098852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4C2DE-DFF4-036A-0623-3394DB34C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1656" y="1339938"/>
            <a:ext cx="11071654" cy="936901"/>
          </a:xfrm>
        </p:spPr>
        <p:txBody>
          <a:bodyPr/>
          <a:lstStyle/>
          <a:p>
            <a:r>
              <a:rPr lang="en-US"/>
              <a:t>Discussion Question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51440" y="2915593"/>
            <a:ext cx="10689120" cy="2084494"/>
          </a:xfrm>
        </p:spPr>
        <p:txBody>
          <a:bodyPr>
            <a:normAutofit fontScale="77500" lnSpcReduction="20000"/>
          </a:bodyPr>
          <a:lstStyle/>
          <a:p>
            <a:pPr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dirty="0"/>
              <a:t> </a:t>
            </a:r>
            <a:r>
              <a:rPr lang="en-US" sz="2600" dirty="0"/>
              <a:t>What are the potential drawbacks of using </a:t>
            </a:r>
            <a:r>
              <a:rPr lang="en-US" sz="2600" dirty="0" err="1"/>
              <a:t>phecodes</a:t>
            </a:r>
            <a:r>
              <a:rPr lang="en-US" sz="2600" dirty="0"/>
              <a:t> to define clinical diagnosis?</a:t>
            </a:r>
          </a:p>
          <a:p>
            <a:pPr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600" dirty="0"/>
              <a:t> </a:t>
            </a:r>
            <a:r>
              <a:rPr lang="en-US" sz="2600"/>
              <a:t>How could the </a:t>
            </a:r>
            <a:r>
              <a:rPr lang="en-US" sz="2600" dirty="0"/>
              <a:t>accuracy of </a:t>
            </a:r>
            <a:r>
              <a:rPr lang="en-US" sz="2600" err="1"/>
              <a:t>phecodes</a:t>
            </a:r>
            <a:r>
              <a:rPr lang="en-US" sz="2600"/>
              <a:t> be </a:t>
            </a:r>
            <a:r>
              <a:rPr lang="en-US" sz="2600" dirty="0"/>
              <a:t>validated?</a:t>
            </a:r>
          </a:p>
          <a:p>
            <a:pPr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600"/>
              <a:t> What </a:t>
            </a:r>
            <a:r>
              <a:rPr lang="en-US" sz="2600" dirty="0"/>
              <a:t>would be the ideal study design and what are the </a:t>
            </a:r>
            <a:r>
              <a:rPr lang="en-US" sz="2600"/>
              <a:t>potential logistical problems of it?</a:t>
            </a:r>
            <a:endParaRPr lang="en-US" sz="2600" dirty="0"/>
          </a:p>
          <a:p>
            <a:pPr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600" dirty="0"/>
              <a:t> How does the selection of individuals affect the generalizability of the findings?</a:t>
            </a:r>
          </a:p>
          <a:p>
            <a:pPr marL="0" indent="0">
              <a:buNone/>
            </a:pPr>
            <a:endParaRPr lang="en-US" sz="2200" dirty="0"/>
          </a:p>
          <a:p>
            <a:pPr marL="0" indent="0">
              <a:buNone/>
            </a:pPr>
            <a:endParaRPr lang="en-US" sz="22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DDA440-BFAD-3CCF-5AD6-A4C11FA1A77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81656" y="6463076"/>
            <a:ext cx="11071654" cy="375258"/>
          </a:xfrm>
        </p:spPr>
        <p:txBody>
          <a:bodyPr>
            <a:normAutofit fontScale="92500" lnSpcReduction="10000"/>
          </a:bodyPr>
          <a:lstStyle/>
          <a:p>
            <a:r>
              <a:rPr lang="en-US"/>
              <a:t>Chung M, Shelley JP, Karakoc G, et al. Clinical conditions associated with a high antinuclear antibody titer in individuals without an autoimmune disease. Arthritis Care Res (Hoboken) 2025. https://doi.org/10.1002/acr.25682</a:t>
            </a:r>
          </a:p>
        </p:txBody>
      </p:sp>
      <p:sp>
        <p:nvSpPr>
          <p:cNvPr id="5" name="Text Placeholder 2">
            <a:extLst>
              <a:ext uri="{FF2B5EF4-FFF2-40B4-BE49-F238E27FC236}">
                <a16:creationId xmlns:a16="http://schemas.microsoft.com/office/drawing/2014/main" id="{2C9C66A4-9900-7A74-4396-E5239C7C6389}"/>
              </a:ext>
            </a:extLst>
          </p:cNvPr>
          <p:cNvSpPr txBox="1">
            <a:spLocks/>
          </p:cNvSpPr>
          <p:nvPr/>
        </p:nvSpPr>
        <p:spPr>
          <a:xfrm>
            <a:off x="481656" y="2365352"/>
            <a:ext cx="11071654" cy="4617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b="1" i="1" dirty="0"/>
              <a:t>Strengths and limitations of the study design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2C9C66A4-9900-7A74-4396-E5239C7C6389}"/>
              </a:ext>
            </a:extLst>
          </p:cNvPr>
          <p:cNvSpPr txBox="1">
            <a:spLocks/>
          </p:cNvSpPr>
          <p:nvPr/>
        </p:nvSpPr>
        <p:spPr>
          <a:xfrm>
            <a:off x="481656" y="4932536"/>
            <a:ext cx="11071654" cy="4617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200" b="1" i="1" dirty="0"/>
              <a:t>Clinical implications and future directions</a:t>
            </a:r>
          </a:p>
        </p:txBody>
      </p:sp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 txBox="1">
            <a:spLocks/>
          </p:cNvSpPr>
          <p:nvPr/>
        </p:nvSpPr>
        <p:spPr>
          <a:xfrm>
            <a:off x="751440" y="5345886"/>
            <a:ext cx="11079645" cy="1173229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200"/>
              <a:t> Should </a:t>
            </a:r>
            <a:r>
              <a:rPr lang="en-US" sz="2200" dirty="0"/>
              <a:t>a high ANA </a:t>
            </a:r>
            <a:r>
              <a:rPr lang="en-US" sz="2200"/>
              <a:t>titer be </a:t>
            </a:r>
            <a:r>
              <a:rPr lang="en-US" sz="2200" dirty="0"/>
              <a:t>enough to warrant testing for liver disease, in which cases?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→"/>
            </a:pPr>
            <a:r>
              <a:rPr lang="en-US" sz="2200" dirty="0"/>
              <a:t> What further research is required to confirm this </a:t>
            </a:r>
            <a:r>
              <a:rPr lang="en-US" sz="2200"/>
              <a:t>finding?</a:t>
            </a:r>
            <a:endParaRPr lang="en-US" sz="2200" dirty="0"/>
          </a:p>
          <a:p>
            <a:pPr marL="0" indent="0">
              <a:buFont typeface="Arial" panose="020B0604020202020204" pitchFamily="34" charset="0"/>
              <a:buNone/>
            </a:pPr>
            <a:endParaRPr lang="en-US" sz="2200" dirty="0"/>
          </a:p>
          <a:p>
            <a:pPr marL="0" indent="0">
              <a:buFont typeface="Arial" panose="020B0604020202020204" pitchFamily="34" charset="0"/>
              <a:buNone/>
            </a:pPr>
            <a:endParaRPr lang="en-US" sz="2200" dirty="0"/>
          </a:p>
          <a:p>
            <a:pPr marL="0" indent="0">
              <a:buFont typeface="Arial" panose="020B0604020202020204" pitchFamily="34" charset="0"/>
              <a:buNone/>
            </a:pPr>
            <a:endParaRPr lang="en-US" sz="2200" dirty="0"/>
          </a:p>
        </p:txBody>
      </p:sp>
    </p:spTree>
    <p:extLst>
      <p:ext uri="{BB962C8B-B14F-4D97-AF65-F5344CB8AC3E}">
        <p14:creationId xmlns:p14="http://schemas.microsoft.com/office/powerpoint/2010/main" val="48817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</TotalTime>
  <Words>1407</Words>
  <Application>Microsoft Office PowerPoint</Application>
  <PresentationFormat>Widescreen</PresentationFormat>
  <Paragraphs>13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ＭＳ Ｐゴシック</vt:lpstr>
      <vt:lpstr>Arial</vt:lpstr>
      <vt:lpstr>Calibri</vt:lpstr>
      <vt:lpstr>Wingdings</vt:lpstr>
      <vt:lpstr>Office Theme</vt:lpstr>
      <vt:lpstr>Clinical Conditions Associated With a High Antinuclear Antibody Titer in Individuals Without Autoimmune Disease</vt:lpstr>
      <vt:lpstr>Background</vt:lpstr>
      <vt:lpstr>Methods</vt:lpstr>
      <vt:lpstr>Results</vt:lpstr>
      <vt:lpstr>Results</vt:lpstr>
      <vt:lpstr>Results</vt:lpstr>
      <vt:lpstr>Discussion</vt:lpstr>
      <vt:lpstr>Discussion Questions</vt:lpstr>
      <vt:lpstr>Discussion Questio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 Aden</dc:creator>
  <cp:lastModifiedBy>Brian Robinson</cp:lastModifiedBy>
  <cp:revision>24</cp:revision>
  <dcterms:created xsi:type="dcterms:W3CDTF">2025-01-16T19:43:53Z</dcterms:created>
  <dcterms:modified xsi:type="dcterms:W3CDTF">2025-12-03T15:26:12Z</dcterms:modified>
</cp:coreProperties>
</file>